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 varScale="1">
        <p:scale>
          <a:sx n="92" d="100"/>
          <a:sy n="92" d="100"/>
        </p:scale>
        <p:origin x="564" y="90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91849C6-8AA1-4C75-8D8A-101E4196526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43D06A47-24A1-44D4-BF6B-E04FB8850B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6E60E62-DE5F-4D0C-8861-B7DE8F19A3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D9B94-6170-4E8D-975D-BF97F37C59CA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2B6256C-7C05-4A1F-A74D-B1CDD3DF0B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AE40842-BAB0-45C0-80A5-384AAA2850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32720-4E39-47E2-919E-73DA3E5BC4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99815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6CDA70B-2FF8-41CC-9058-D550CCEED8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6AE1033-61B7-43C7-B2FE-08C0F2D38F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803100B-0CEC-44C3-AE01-3431F8864D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D9B94-6170-4E8D-975D-BF97F37C59CA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8AD8533-A1AB-493C-98C2-4E90206A3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7EED646-8187-4426-9699-1B556F0900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32720-4E39-47E2-919E-73DA3E5BC4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81651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7E7A6800-30A1-4EBE-9C1B-E6D39FC6EB9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2016CD6-7738-490A-8A57-1DD1FA3D72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C88FD05-74EF-41D1-A02D-4CE34BA76D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D9B94-6170-4E8D-975D-BF97F37C59CA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E312D8D-04F3-4D20-B944-24E586C912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A58B2E5-DD65-4479-8FC9-37853566E1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32720-4E39-47E2-919E-73DA3E5BC4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63876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B1F17C7-E072-47D0-8FB1-BBBB48070D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BC4F5EF-2567-4F4F-B4A7-458478416F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5014D57-819C-435B-AE8F-48EA95C1CE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D9B94-6170-4E8D-975D-BF97F37C59CA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5FF69EF-2812-4AA0-B96E-F9225EFA18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8FEFFE7-2FD1-4851-A132-C8F489922A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32720-4E39-47E2-919E-73DA3E5BC4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6211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82D54D5-E496-409F-B2A6-D63BED4123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A5CE3F1-802B-4783-B258-3482E908E3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75F6CCD-60EA-4AD7-BE20-3C27ACE7B1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D9B94-6170-4E8D-975D-BF97F37C59CA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689F6C1-60EE-4542-8135-2E87B33379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BEDEAEF-3BC7-4147-BD6D-65AC485AD6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32720-4E39-47E2-919E-73DA3E5BC4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2261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7C9E2F8-3E89-493B-BC0E-9F14CD244E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903EB26-EECA-45C7-850E-7C10A8FAE7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0FD6CE7-0349-4901-AC27-CA02D02C79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180905B-2E6A-4F78-8DC5-9689EEC3B8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D9B94-6170-4E8D-975D-BF97F37C59CA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9771D52-DDD8-4D73-9BBF-91D4C643E1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43E1715-C7D6-441E-B58B-6D8DF16CE1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32720-4E39-47E2-919E-73DA3E5BC4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97112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BE98608-984C-4B3D-9969-786B78880D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93A60F3-0401-45CE-801F-6A7CE4AA64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43789E04-AE29-42B8-B550-84555EED68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723DF75D-6E48-4006-8C75-F18F25526E1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28BBF133-8505-4CAC-88E7-8DC7321CCD2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406DC9FA-8F53-40C0-87F9-CF525DC3E3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D9B94-6170-4E8D-975D-BF97F37C59CA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4058C942-AE35-4642-B8E6-B125C7B1B5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0E3F47CF-F2B2-4772-A5F2-0CC1DB5494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32720-4E39-47E2-919E-73DA3E5BC4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92808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A9F85CA-99A4-4632-9863-B568310949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088CC67F-EFCD-4B64-98E7-0AC70D20CA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D9B94-6170-4E8D-975D-BF97F37C59CA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CB623A37-7C23-4872-A43B-5526914A70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C49C88AD-2D56-4A5E-A6B6-8AE02EAF17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32720-4E39-47E2-919E-73DA3E5BC4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3091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8130DEAF-EE86-4E0B-8E0C-8D44A99944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D9B94-6170-4E8D-975D-BF97F37C59CA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918BE467-E29F-4909-AEB9-C270AEBBF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ED8E14B8-869F-43F2-87ED-19E49DD03B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32720-4E39-47E2-919E-73DA3E5BC4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1279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EFCE64F-9010-4C99-B1F2-34A21019D1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8B49065-B052-40DE-8F82-56D224BA31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B1761C1-D680-42CF-8D96-491737012A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4A82737-BE06-46C9-89A0-6F49CFCE7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D9B94-6170-4E8D-975D-BF97F37C59CA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B5F681D-1294-4327-8D26-7B352E8000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0ACE103-4FF0-4B04-8647-77AE36144A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32720-4E39-47E2-919E-73DA3E5BC4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9791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94426EC-D24E-4259-839F-849C9D647F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E116F623-6306-4DFD-9C45-183EC9337C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DE2AD737-575E-42E4-A1EE-ADE803C79F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5FB4BED-79BA-4109-8A06-383AAAD845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D9B94-6170-4E8D-975D-BF97F37C59CA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82FC24F-B3EC-4CC1-AFC6-3C58823F8E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21986D8-8FAF-459F-8F73-2366F2F091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32720-4E39-47E2-919E-73DA3E5BC4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22471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25A82F40-1202-4887-AE7B-3C03CFDBE0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0ADCF4E-EA09-4A9A-96ED-FA1C25703F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62CE6C2-5E6D-4CE9-9A51-F28B5CADD34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2D9B94-6170-4E8D-975D-BF97F37C59CA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521DCF8-A971-447E-A781-6931261142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19BF49F-FA01-4FFB-9CF9-2DE02A5916F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232720-4E39-47E2-919E-73DA3E5BC4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06804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>
            <a:extLst>
              <a:ext uri="{FF2B5EF4-FFF2-40B4-BE49-F238E27FC236}">
                <a16:creationId xmlns:a16="http://schemas.microsoft.com/office/drawing/2014/main" id="{9BF76354-4BA3-43C8-B591-788FAB48C454}"/>
              </a:ext>
            </a:extLst>
          </p:cNvPr>
          <p:cNvSpPr txBox="1"/>
          <p:nvPr/>
        </p:nvSpPr>
        <p:spPr>
          <a:xfrm>
            <a:off x="81079" y="63968"/>
            <a:ext cx="1119217" cy="33855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lvl="0">
              <a:defRPr lang="ko-KR" altLang="en-US"/>
            </a:pPr>
            <a:r>
              <a:rPr lang="en-US" sz="1600" b="1">
                <a:latin typeface="Helvetica" panose="020B0604020202020204" pitchFamily="34" charset="0"/>
                <a:cs typeface="Helvetica" panose="020B0604020202020204" pitchFamily="34" charset="0"/>
              </a:rPr>
              <a:t>Figure </a:t>
            </a:r>
            <a:r>
              <a:rPr lang="en-US" altLang="ko-KR" sz="1600" b="1">
                <a:latin typeface="Helvetica" panose="020B0604020202020204" pitchFamily="34" charset="0"/>
                <a:cs typeface="Helvetica" panose="020B0604020202020204" pitchFamily="34" charset="0"/>
              </a:rPr>
              <a:t>S2</a:t>
            </a:r>
            <a:endParaRPr lang="en-US" sz="16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0196175C-8191-4A58-A005-21063E6C35A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1531" y="193693"/>
            <a:ext cx="8819773" cy="6610515"/>
          </a:xfrm>
          <a:prstGeom prst="rect">
            <a:avLst/>
          </a:prstGeom>
        </p:spPr>
      </p:pic>
      <p:cxnSp>
        <p:nvCxnSpPr>
          <p:cNvPr id="9" name="직선 연결선 8">
            <a:extLst>
              <a:ext uri="{FF2B5EF4-FFF2-40B4-BE49-F238E27FC236}">
                <a16:creationId xmlns:a16="http://schemas.microsoft.com/office/drawing/2014/main" id="{E5419DAA-73D6-4763-9E13-163091CCE0D4}"/>
              </a:ext>
            </a:extLst>
          </p:cNvPr>
          <p:cNvCxnSpPr>
            <a:cxnSpLocks/>
          </p:cNvCxnSpPr>
          <p:nvPr/>
        </p:nvCxnSpPr>
        <p:spPr>
          <a:xfrm flipV="1">
            <a:off x="5371432" y="260392"/>
            <a:ext cx="0" cy="6156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직선 연결선 33">
            <a:extLst>
              <a:ext uri="{FF2B5EF4-FFF2-40B4-BE49-F238E27FC236}">
                <a16:creationId xmlns:a16="http://schemas.microsoft.com/office/drawing/2014/main" id="{927F0F3C-E831-4D58-AAD4-A3CEA31590ED}"/>
              </a:ext>
            </a:extLst>
          </p:cNvPr>
          <p:cNvCxnSpPr>
            <a:cxnSpLocks/>
          </p:cNvCxnSpPr>
          <p:nvPr/>
        </p:nvCxnSpPr>
        <p:spPr>
          <a:xfrm flipH="1">
            <a:off x="2046804" y="3621266"/>
            <a:ext cx="828409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081D1D7D-85AD-4C96-8637-E96C01BA5308}"/>
              </a:ext>
            </a:extLst>
          </p:cNvPr>
          <p:cNvSpPr txBox="1"/>
          <p:nvPr/>
        </p:nvSpPr>
        <p:spPr>
          <a:xfrm>
            <a:off x="1973141" y="5109358"/>
            <a:ext cx="1090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i="1" dirty="0">
                <a:latin typeface="Calibri" panose="020F0502020204030204" pitchFamily="34" charset="0"/>
                <a:cs typeface="Calibri" panose="020F0502020204030204" pitchFamily="34" charset="0"/>
              </a:rPr>
              <a:t>P. </a:t>
            </a:r>
            <a:r>
              <a:rPr lang="en-US" altLang="ko-KR" sz="1200" i="1" dirty="0" err="1">
                <a:latin typeface="Calibri" panose="020F0502020204030204" pitchFamily="34" charset="0"/>
                <a:cs typeface="Calibri" panose="020F0502020204030204" pitchFamily="34" charset="0"/>
              </a:rPr>
              <a:t>deltoides</a:t>
            </a:r>
            <a:endParaRPr lang="ko-KR" altLang="en-US" sz="1200" i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9C2326D-D1DD-46B1-BC83-5EBBCFD5F7FC}"/>
              </a:ext>
            </a:extLst>
          </p:cNvPr>
          <p:cNvSpPr txBox="1"/>
          <p:nvPr/>
        </p:nvSpPr>
        <p:spPr>
          <a:xfrm>
            <a:off x="5141259" y="4188081"/>
            <a:ext cx="1090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i="1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. </a:t>
            </a:r>
            <a:r>
              <a:rPr lang="en-US" altLang="ko-KR" sz="1200" i="1" dirty="0" err="1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tremuloides</a:t>
            </a:r>
            <a:endParaRPr lang="ko-KR" altLang="en-US" sz="1200" i="1" dirty="0">
              <a:solidFill>
                <a:srgbClr val="0070C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3091573-B85A-4FDD-AFA8-A19C4216AFF3}"/>
              </a:ext>
            </a:extLst>
          </p:cNvPr>
          <p:cNvSpPr txBox="1"/>
          <p:nvPr/>
        </p:nvSpPr>
        <p:spPr>
          <a:xfrm>
            <a:off x="2206502" y="3414508"/>
            <a:ext cx="1090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i="1" dirty="0">
                <a:latin typeface="Calibri" panose="020F0502020204030204" pitchFamily="34" charset="0"/>
                <a:cs typeface="Calibri" panose="020F0502020204030204" pitchFamily="34" charset="0"/>
              </a:rPr>
              <a:t>P. </a:t>
            </a:r>
            <a:r>
              <a:rPr lang="en-US" altLang="ko-KR" sz="1200" i="1" dirty="0" err="1">
                <a:latin typeface="Calibri" panose="020F0502020204030204" pitchFamily="34" charset="0"/>
                <a:cs typeface="Calibri" panose="020F0502020204030204" pitchFamily="34" charset="0"/>
              </a:rPr>
              <a:t>trichocarpa</a:t>
            </a:r>
            <a:endParaRPr lang="ko-KR" altLang="en-US" sz="1200" i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0F77A67-7273-4D7B-B08F-DA1D8E3E6720}"/>
              </a:ext>
            </a:extLst>
          </p:cNvPr>
          <p:cNvSpPr txBox="1"/>
          <p:nvPr/>
        </p:nvSpPr>
        <p:spPr>
          <a:xfrm>
            <a:off x="3792411" y="2915952"/>
            <a:ext cx="12367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i="1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. </a:t>
            </a:r>
            <a:r>
              <a:rPr lang="en-US" altLang="ko-KR" sz="1200" i="1" dirty="0" err="1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tremula</a:t>
            </a:r>
            <a:r>
              <a:rPr lang="en-US" altLang="ko-KR" sz="1200" i="1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ko-KR" sz="1200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x</a:t>
            </a:r>
            <a:r>
              <a:rPr lang="en-US" altLang="ko-KR" sz="1200" i="1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alba</a:t>
            </a:r>
            <a:endParaRPr lang="ko-KR" altLang="en-US" sz="1200" i="1" dirty="0">
              <a:solidFill>
                <a:srgbClr val="0070C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6B9AEB2-071F-4EB2-964D-25566F95719C}"/>
              </a:ext>
            </a:extLst>
          </p:cNvPr>
          <p:cNvSpPr txBox="1"/>
          <p:nvPr/>
        </p:nvSpPr>
        <p:spPr>
          <a:xfrm>
            <a:off x="3803523" y="1663830"/>
            <a:ext cx="10288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i="1" dirty="0">
                <a:solidFill>
                  <a:srgbClr val="00B05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. </a:t>
            </a:r>
            <a:r>
              <a:rPr lang="en-US" altLang="ko-KR" sz="1200" i="1" dirty="0" err="1">
                <a:solidFill>
                  <a:srgbClr val="00B05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euphratica</a:t>
            </a:r>
            <a:endParaRPr lang="ko-KR" altLang="en-US" sz="1200" i="1" dirty="0">
              <a:solidFill>
                <a:srgbClr val="00B05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F31535D-1D14-4FFF-BD1A-73FDB0A17355}"/>
              </a:ext>
            </a:extLst>
          </p:cNvPr>
          <p:cNvSpPr txBox="1"/>
          <p:nvPr/>
        </p:nvSpPr>
        <p:spPr>
          <a:xfrm>
            <a:off x="7692411" y="264022"/>
            <a:ext cx="9181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i="1" dirty="0">
                <a:solidFill>
                  <a:srgbClr val="00B05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. </a:t>
            </a:r>
            <a:r>
              <a:rPr lang="en-US" altLang="ko-KR" sz="1200" i="1" dirty="0" err="1">
                <a:solidFill>
                  <a:srgbClr val="00B05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uinosa</a:t>
            </a:r>
            <a:endParaRPr lang="ko-KR" altLang="en-US" sz="1200" i="1" dirty="0">
              <a:solidFill>
                <a:srgbClr val="00B05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E873C14-8F9A-4887-B694-00AC6AB6213B}"/>
              </a:ext>
            </a:extLst>
          </p:cNvPr>
          <p:cNvSpPr txBox="1"/>
          <p:nvPr/>
        </p:nvSpPr>
        <p:spPr>
          <a:xfrm>
            <a:off x="9543443" y="5857231"/>
            <a:ext cx="8477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i="1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. </a:t>
            </a:r>
            <a:r>
              <a:rPr lang="en-US" altLang="ko-KR" sz="1200" i="1" dirty="0" err="1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tremula</a:t>
            </a:r>
            <a:endParaRPr lang="ko-KR" altLang="en-US" sz="1200" i="1" dirty="0">
              <a:solidFill>
                <a:srgbClr val="0070C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" name="Oval 1">
            <a:extLst>
              <a:ext uri="{FF2B5EF4-FFF2-40B4-BE49-F238E27FC236}">
                <a16:creationId xmlns:a16="http://schemas.microsoft.com/office/drawing/2014/main" id="{C6C1DF73-1673-4EE6-9FDE-C8AB7AAB2D0E}"/>
              </a:ext>
            </a:extLst>
          </p:cNvPr>
          <p:cNvSpPr/>
          <p:nvPr/>
        </p:nvSpPr>
        <p:spPr>
          <a:xfrm rot="2348688">
            <a:off x="2208443" y="1443140"/>
            <a:ext cx="3750518" cy="4829518"/>
          </a:xfrm>
          <a:prstGeom prst="ellipse">
            <a:avLst/>
          </a:prstGeom>
          <a:noFill/>
          <a:ln w="25400"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1614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4</TotalTime>
  <Words>25</Words>
  <Application>Microsoft Office PowerPoint</Application>
  <PresentationFormat>와이드스크린</PresentationFormat>
  <Paragraphs>8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Helvetica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윤윤호</dc:creator>
  <cp:lastModifiedBy>김 만기</cp:lastModifiedBy>
  <cp:revision>41</cp:revision>
  <dcterms:created xsi:type="dcterms:W3CDTF">2021-07-07T01:28:56Z</dcterms:created>
  <dcterms:modified xsi:type="dcterms:W3CDTF">2021-07-15T05:31:21Z</dcterms:modified>
</cp:coreProperties>
</file>